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07200" cy="9906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298" y="-5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NEO singoli pts'!$K$22</c:f>
              <c:strCache>
                <c:ptCount val="1"/>
                <c:pt idx="0">
                  <c:v>E:T 2:1</c:v>
                </c:pt>
              </c:strCache>
            </c:strRef>
          </c:tx>
          <c:invertIfNegative val="0"/>
          <c:cat>
            <c:strRef>
              <c:f>'NEO singoli pts'!$J$23:$J$40</c:f>
              <c:strCache>
                <c:ptCount val="18"/>
                <c:pt idx="0">
                  <c:v>SG</c:v>
                </c:pt>
                <c:pt idx="1">
                  <c:v>SG+Trast</c:v>
                </c:pt>
                <c:pt idx="2">
                  <c:v>BB</c:v>
                </c:pt>
                <c:pt idx="3">
                  <c:v>BB+Trast</c:v>
                </c:pt>
                <c:pt idx="4">
                  <c:v>PT</c:v>
                </c:pt>
                <c:pt idx="5">
                  <c:v>PT+Trast</c:v>
                </c:pt>
                <c:pt idx="6">
                  <c:v>CF</c:v>
                </c:pt>
                <c:pt idx="7">
                  <c:v>CF+Trast</c:v>
                </c:pt>
                <c:pt idx="8">
                  <c:v>RA</c:v>
                </c:pt>
                <c:pt idx="9">
                  <c:v>RA+Trast</c:v>
                </c:pt>
                <c:pt idx="10">
                  <c:v>TC</c:v>
                </c:pt>
                <c:pt idx="11">
                  <c:v>TC+Trast</c:v>
                </c:pt>
                <c:pt idx="12">
                  <c:v>FR</c:v>
                </c:pt>
                <c:pt idx="13">
                  <c:v>FR+Trast</c:v>
                </c:pt>
                <c:pt idx="14">
                  <c:v>PA</c:v>
                </c:pt>
                <c:pt idx="15">
                  <c:v>PA+Trast</c:v>
                </c:pt>
                <c:pt idx="16">
                  <c:v>CM</c:v>
                </c:pt>
                <c:pt idx="17">
                  <c:v>CM+Trast</c:v>
                </c:pt>
              </c:strCache>
            </c:strRef>
          </c:cat>
          <c:val>
            <c:numRef>
              <c:f>'NEO singoli pts'!$K$23:$K$40</c:f>
              <c:numCache>
                <c:formatCode>0.00</c:formatCode>
                <c:ptCount val="18"/>
                <c:pt idx="0">
                  <c:v>0.25</c:v>
                </c:pt>
                <c:pt idx="1">
                  <c:v>0</c:v>
                </c:pt>
                <c:pt idx="2">
                  <c:v>62.15</c:v>
                </c:pt>
                <c:pt idx="3">
                  <c:v>28.35</c:v>
                </c:pt>
                <c:pt idx="4">
                  <c:v>1.139</c:v>
                </c:pt>
                <c:pt idx="5">
                  <c:v>8.0719999999999992</c:v>
                </c:pt>
                <c:pt idx="6">
                  <c:v>0.34370000000000001</c:v>
                </c:pt>
                <c:pt idx="7">
                  <c:v>8.0719999999999992</c:v>
                </c:pt>
                <c:pt idx="8">
                  <c:v>0.45500000000000002</c:v>
                </c:pt>
                <c:pt idx="9">
                  <c:v>2.0979999999999999</c:v>
                </c:pt>
                <c:pt idx="10">
                  <c:v>0.92669999999999997</c:v>
                </c:pt>
                <c:pt idx="11">
                  <c:v>7.0119999999999996</c:v>
                </c:pt>
                <c:pt idx="12">
                  <c:v>0.53090000000000004</c:v>
                </c:pt>
                <c:pt idx="13">
                  <c:v>1.359</c:v>
                </c:pt>
                <c:pt idx="14">
                  <c:v>0.53090000000000004</c:v>
                </c:pt>
                <c:pt idx="15">
                  <c:v>1.6180000000000001</c:v>
                </c:pt>
                <c:pt idx="16">
                  <c:v>1.9490000000000001</c:v>
                </c:pt>
                <c:pt idx="17">
                  <c:v>1.9490000000000001</c:v>
                </c:pt>
              </c:numCache>
            </c:numRef>
          </c:val>
        </c:ser>
        <c:ser>
          <c:idx val="1"/>
          <c:order val="1"/>
          <c:tx>
            <c:strRef>
              <c:f>'NEO singoli pts'!$L$22</c:f>
              <c:strCache>
                <c:ptCount val="1"/>
                <c:pt idx="0">
                  <c:v>E:T 5:1</c:v>
                </c:pt>
              </c:strCache>
            </c:strRef>
          </c:tx>
          <c:invertIfNegative val="0"/>
          <c:cat>
            <c:strRef>
              <c:f>'NEO singoli pts'!$J$23:$J$40</c:f>
              <c:strCache>
                <c:ptCount val="18"/>
                <c:pt idx="0">
                  <c:v>SG</c:v>
                </c:pt>
                <c:pt idx="1">
                  <c:v>SG+Trast</c:v>
                </c:pt>
                <c:pt idx="2">
                  <c:v>BB</c:v>
                </c:pt>
                <c:pt idx="3">
                  <c:v>BB+Trast</c:v>
                </c:pt>
                <c:pt idx="4">
                  <c:v>PT</c:v>
                </c:pt>
                <c:pt idx="5">
                  <c:v>PT+Trast</c:v>
                </c:pt>
                <c:pt idx="6">
                  <c:v>CF</c:v>
                </c:pt>
                <c:pt idx="7">
                  <c:v>CF+Trast</c:v>
                </c:pt>
                <c:pt idx="8">
                  <c:v>RA</c:v>
                </c:pt>
                <c:pt idx="9">
                  <c:v>RA+Trast</c:v>
                </c:pt>
                <c:pt idx="10">
                  <c:v>TC</c:v>
                </c:pt>
                <c:pt idx="11">
                  <c:v>TC+Trast</c:v>
                </c:pt>
                <c:pt idx="12">
                  <c:v>FR</c:v>
                </c:pt>
                <c:pt idx="13">
                  <c:v>FR+Trast</c:v>
                </c:pt>
                <c:pt idx="14">
                  <c:v>PA</c:v>
                </c:pt>
                <c:pt idx="15">
                  <c:v>PA+Trast</c:v>
                </c:pt>
                <c:pt idx="16">
                  <c:v>CM</c:v>
                </c:pt>
                <c:pt idx="17">
                  <c:v>CM+Trast</c:v>
                </c:pt>
              </c:strCache>
            </c:strRef>
          </c:cat>
          <c:val>
            <c:numRef>
              <c:f>'NEO singoli pts'!$L$23:$L$40</c:f>
              <c:numCache>
                <c:formatCode>0.00</c:formatCode>
                <c:ptCount val="18"/>
                <c:pt idx="0">
                  <c:v>0.25</c:v>
                </c:pt>
                <c:pt idx="1">
                  <c:v>1.82</c:v>
                </c:pt>
                <c:pt idx="2">
                  <c:v>52.37</c:v>
                </c:pt>
                <c:pt idx="3">
                  <c:v>42.62</c:v>
                </c:pt>
                <c:pt idx="4">
                  <c:v>0.94530000000000003</c:v>
                </c:pt>
                <c:pt idx="5">
                  <c:v>9.1189999999999998</c:v>
                </c:pt>
                <c:pt idx="6">
                  <c:v>1.225E-2</c:v>
                </c:pt>
                <c:pt idx="7">
                  <c:v>9.1189999999999998</c:v>
                </c:pt>
                <c:pt idx="8">
                  <c:v>0</c:v>
                </c:pt>
                <c:pt idx="9">
                  <c:v>3.4630000000000001</c:v>
                </c:pt>
                <c:pt idx="10">
                  <c:v>0.71479999999999999</c:v>
                </c:pt>
                <c:pt idx="11">
                  <c:v>10.6</c:v>
                </c:pt>
                <c:pt idx="12">
                  <c:v>0.89929999999999999</c:v>
                </c:pt>
                <c:pt idx="13">
                  <c:v>1.1659999999999999</c:v>
                </c:pt>
                <c:pt idx="14">
                  <c:v>0.89929999999999999</c:v>
                </c:pt>
                <c:pt idx="15">
                  <c:v>3.944</c:v>
                </c:pt>
                <c:pt idx="16">
                  <c:v>1.24</c:v>
                </c:pt>
                <c:pt idx="17">
                  <c:v>1.24</c:v>
                </c:pt>
              </c:numCache>
            </c:numRef>
          </c:val>
        </c:ser>
        <c:ser>
          <c:idx val="2"/>
          <c:order val="2"/>
          <c:tx>
            <c:strRef>
              <c:f>'NEO singoli pts'!$M$22</c:f>
              <c:strCache>
                <c:ptCount val="1"/>
                <c:pt idx="0">
                  <c:v>E:T 10:1</c:v>
                </c:pt>
              </c:strCache>
            </c:strRef>
          </c:tx>
          <c:invertIfNegative val="0"/>
          <c:cat>
            <c:strRef>
              <c:f>'NEO singoli pts'!$J$23:$J$40</c:f>
              <c:strCache>
                <c:ptCount val="18"/>
                <c:pt idx="0">
                  <c:v>SG</c:v>
                </c:pt>
                <c:pt idx="1">
                  <c:v>SG+Trast</c:v>
                </c:pt>
                <c:pt idx="2">
                  <c:v>BB</c:v>
                </c:pt>
                <c:pt idx="3">
                  <c:v>BB+Trast</c:v>
                </c:pt>
                <c:pt idx="4">
                  <c:v>PT</c:v>
                </c:pt>
                <c:pt idx="5">
                  <c:v>PT+Trast</c:v>
                </c:pt>
                <c:pt idx="6">
                  <c:v>CF</c:v>
                </c:pt>
                <c:pt idx="7">
                  <c:v>CF+Trast</c:v>
                </c:pt>
                <c:pt idx="8">
                  <c:v>RA</c:v>
                </c:pt>
                <c:pt idx="9">
                  <c:v>RA+Trast</c:v>
                </c:pt>
                <c:pt idx="10">
                  <c:v>TC</c:v>
                </c:pt>
                <c:pt idx="11">
                  <c:v>TC+Trast</c:v>
                </c:pt>
                <c:pt idx="12">
                  <c:v>FR</c:v>
                </c:pt>
                <c:pt idx="13">
                  <c:v>FR+Trast</c:v>
                </c:pt>
                <c:pt idx="14">
                  <c:v>PA</c:v>
                </c:pt>
                <c:pt idx="15">
                  <c:v>PA+Trast</c:v>
                </c:pt>
                <c:pt idx="16">
                  <c:v>CM</c:v>
                </c:pt>
                <c:pt idx="17">
                  <c:v>CM+Trast</c:v>
                </c:pt>
              </c:strCache>
            </c:strRef>
          </c:cat>
          <c:val>
            <c:numRef>
              <c:f>'NEO singoli pts'!$M$23:$M$40</c:f>
              <c:numCache>
                <c:formatCode>0.00</c:formatCode>
                <c:ptCount val="18"/>
                <c:pt idx="0">
                  <c:v>0.25</c:v>
                </c:pt>
                <c:pt idx="1">
                  <c:v>15.2</c:v>
                </c:pt>
                <c:pt idx="2">
                  <c:v>40.51</c:v>
                </c:pt>
                <c:pt idx="3">
                  <c:v>54.06</c:v>
                </c:pt>
                <c:pt idx="4">
                  <c:v>0.61370000000000002</c:v>
                </c:pt>
                <c:pt idx="5">
                  <c:v>17.600000000000001</c:v>
                </c:pt>
                <c:pt idx="6">
                  <c:v>0.4572</c:v>
                </c:pt>
                <c:pt idx="7">
                  <c:v>17.600000000000001</c:v>
                </c:pt>
                <c:pt idx="8">
                  <c:v>0</c:v>
                </c:pt>
                <c:pt idx="9">
                  <c:v>1.8959999999999999</c:v>
                </c:pt>
                <c:pt idx="10">
                  <c:v>0.80700000000000005</c:v>
                </c:pt>
                <c:pt idx="11">
                  <c:v>4.4889999999999999</c:v>
                </c:pt>
                <c:pt idx="12">
                  <c:v>0.74260000000000004</c:v>
                </c:pt>
                <c:pt idx="13">
                  <c:v>3.863</c:v>
                </c:pt>
                <c:pt idx="14">
                  <c:v>0.74260000000000004</c:v>
                </c:pt>
                <c:pt idx="15">
                  <c:v>3.9689999999999999</c:v>
                </c:pt>
                <c:pt idx="16">
                  <c:v>0.60060000000000002</c:v>
                </c:pt>
                <c:pt idx="17">
                  <c:v>0.60060000000000002</c:v>
                </c:pt>
              </c:numCache>
            </c:numRef>
          </c:val>
        </c:ser>
        <c:ser>
          <c:idx val="3"/>
          <c:order val="3"/>
          <c:tx>
            <c:strRef>
              <c:f>'NEO singoli pts'!$N$22</c:f>
              <c:strCache>
                <c:ptCount val="1"/>
                <c:pt idx="0">
                  <c:v>E:T 20:1</c:v>
                </c:pt>
              </c:strCache>
            </c:strRef>
          </c:tx>
          <c:invertIfNegative val="0"/>
          <c:cat>
            <c:strRef>
              <c:f>'NEO singoli pts'!$J$23:$J$40</c:f>
              <c:strCache>
                <c:ptCount val="18"/>
                <c:pt idx="0">
                  <c:v>SG</c:v>
                </c:pt>
                <c:pt idx="1">
                  <c:v>SG+Trast</c:v>
                </c:pt>
                <c:pt idx="2">
                  <c:v>BB</c:v>
                </c:pt>
                <c:pt idx="3">
                  <c:v>BB+Trast</c:v>
                </c:pt>
                <c:pt idx="4">
                  <c:v>PT</c:v>
                </c:pt>
                <c:pt idx="5">
                  <c:v>PT+Trast</c:v>
                </c:pt>
                <c:pt idx="6">
                  <c:v>CF</c:v>
                </c:pt>
                <c:pt idx="7">
                  <c:v>CF+Trast</c:v>
                </c:pt>
                <c:pt idx="8">
                  <c:v>RA</c:v>
                </c:pt>
                <c:pt idx="9">
                  <c:v>RA+Trast</c:v>
                </c:pt>
                <c:pt idx="10">
                  <c:v>TC</c:v>
                </c:pt>
                <c:pt idx="11">
                  <c:v>TC+Trast</c:v>
                </c:pt>
                <c:pt idx="12">
                  <c:v>FR</c:v>
                </c:pt>
                <c:pt idx="13">
                  <c:v>FR+Trast</c:v>
                </c:pt>
                <c:pt idx="14">
                  <c:v>PA</c:v>
                </c:pt>
                <c:pt idx="15">
                  <c:v>PA+Trast</c:v>
                </c:pt>
                <c:pt idx="16">
                  <c:v>CM</c:v>
                </c:pt>
                <c:pt idx="17">
                  <c:v>CM+Trast</c:v>
                </c:pt>
              </c:strCache>
            </c:strRef>
          </c:cat>
          <c:val>
            <c:numRef>
              <c:f>'NEO singoli pts'!$N$23:$N$40</c:f>
              <c:numCache>
                <c:formatCode>0.00</c:formatCode>
                <c:ptCount val="18"/>
                <c:pt idx="0">
                  <c:v>0.25</c:v>
                </c:pt>
                <c:pt idx="1">
                  <c:v>28.29</c:v>
                </c:pt>
                <c:pt idx="2">
                  <c:v>31.06</c:v>
                </c:pt>
                <c:pt idx="3">
                  <c:v>63.85</c:v>
                </c:pt>
                <c:pt idx="4">
                  <c:v>0.69350000000000001</c:v>
                </c:pt>
                <c:pt idx="5">
                  <c:v>19.38</c:v>
                </c:pt>
                <c:pt idx="6">
                  <c:v>0</c:v>
                </c:pt>
                <c:pt idx="7">
                  <c:v>19.38</c:v>
                </c:pt>
                <c:pt idx="8">
                  <c:v>0</c:v>
                </c:pt>
                <c:pt idx="9">
                  <c:v>11.32</c:v>
                </c:pt>
                <c:pt idx="10">
                  <c:v>1.6539999999999999</c:v>
                </c:pt>
                <c:pt idx="11">
                  <c:v>8.3829999999999991</c:v>
                </c:pt>
                <c:pt idx="12">
                  <c:v>1.0620000000000001</c:v>
                </c:pt>
                <c:pt idx="13">
                  <c:v>6.266</c:v>
                </c:pt>
                <c:pt idx="14">
                  <c:v>1.0620000000000001</c:v>
                </c:pt>
                <c:pt idx="15">
                  <c:v>11.07</c:v>
                </c:pt>
                <c:pt idx="16">
                  <c:v>5.1980000000000004</c:v>
                </c:pt>
                <c:pt idx="17">
                  <c:v>5.19800000000000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0767744"/>
        <c:axId val="70768512"/>
      </c:barChart>
      <c:catAx>
        <c:axId val="70767744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70768512"/>
        <c:crosses val="autoZero"/>
        <c:auto val="1"/>
        <c:lblAlgn val="ctr"/>
        <c:lblOffset val="100"/>
        <c:noMultiLvlLbl val="0"/>
      </c:catAx>
      <c:valAx>
        <c:axId val="70768512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70767744"/>
        <c:crosses val="autoZero"/>
        <c:crossBetween val="between"/>
      </c:valAx>
      <c:spPr>
        <a:ln>
          <a:noFill/>
        </a:ln>
      </c:spPr>
    </c:plotArea>
    <c:legend>
      <c:legendPos val="r"/>
      <c:layout>
        <c:manualLayout>
          <c:xMode val="edge"/>
          <c:yMode val="edge"/>
          <c:x val="0.68962899118129706"/>
          <c:y val="7.4405803441236512E-2"/>
          <c:w val="0.13226340213966761"/>
          <c:h val="0.31415135608048994"/>
        </c:manualLayout>
      </c:layout>
      <c:overlay val="0"/>
      <c:txPr>
        <a:bodyPr/>
        <a:lstStyle/>
        <a:p>
          <a:pPr>
            <a:defRPr b="1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NEO singoli pts'!$K$81</c:f>
              <c:strCache>
                <c:ptCount val="1"/>
                <c:pt idx="0">
                  <c:v>E:T 2:1</c:v>
                </c:pt>
              </c:strCache>
            </c:strRef>
          </c:tx>
          <c:invertIfNegative val="0"/>
          <c:cat>
            <c:strRef>
              <c:f>'NEO singoli pts'!$J$82:$J$101</c:f>
              <c:strCache>
                <c:ptCount val="20"/>
                <c:pt idx="0">
                  <c:v>SG</c:v>
                </c:pt>
                <c:pt idx="1">
                  <c:v>SG+Trast</c:v>
                </c:pt>
                <c:pt idx="2">
                  <c:v>BB</c:v>
                </c:pt>
                <c:pt idx="3">
                  <c:v>BB+Trast</c:v>
                </c:pt>
                <c:pt idx="4">
                  <c:v>PT</c:v>
                </c:pt>
                <c:pt idx="5">
                  <c:v>PT+Trast</c:v>
                </c:pt>
                <c:pt idx="6">
                  <c:v>TC</c:v>
                </c:pt>
                <c:pt idx="7">
                  <c:v>TC+Trast</c:v>
                </c:pt>
                <c:pt idx="8">
                  <c:v>CF</c:v>
                </c:pt>
                <c:pt idx="9">
                  <c:v>CF+Trast</c:v>
                </c:pt>
                <c:pt idx="10">
                  <c:v>PA</c:v>
                </c:pt>
                <c:pt idx="11">
                  <c:v>PA+Trast</c:v>
                </c:pt>
                <c:pt idx="12">
                  <c:v>CM</c:v>
                </c:pt>
                <c:pt idx="13">
                  <c:v>CM+Trast</c:v>
                </c:pt>
                <c:pt idx="14">
                  <c:v>ML</c:v>
                </c:pt>
                <c:pt idx="15">
                  <c:v>ML+Trast</c:v>
                </c:pt>
                <c:pt idx="16">
                  <c:v>KAN</c:v>
                </c:pt>
                <c:pt idx="17">
                  <c:v>KAN+Trast</c:v>
                </c:pt>
                <c:pt idx="18">
                  <c:v>FR</c:v>
                </c:pt>
                <c:pt idx="19">
                  <c:v>FR+Trast</c:v>
                </c:pt>
              </c:strCache>
            </c:strRef>
          </c:cat>
          <c:val>
            <c:numRef>
              <c:f>'NEO singoli pts'!$K$82:$K$101</c:f>
              <c:numCache>
                <c:formatCode>0.00</c:formatCode>
                <c:ptCount val="20"/>
                <c:pt idx="0">
                  <c:v>0.25</c:v>
                </c:pt>
                <c:pt idx="1">
                  <c:v>0</c:v>
                </c:pt>
                <c:pt idx="2">
                  <c:v>31.06</c:v>
                </c:pt>
                <c:pt idx="3">
                  <c:v>28.35</c:v>
                </c:pt>
                <c:pt idx="4">
                  <c:v>0.69350000000000001</c:v>
                </c:pt>
                <c:pt idx="5">
                  <c:v>8.0719999999999992</c:v>
                </c:pt>
                <c:pt idx="6">
                  <c:v>1.6539999999999999</c:v>
                </c:pt>
                <c:pt idx="7">
                  <c:v>7.0119999999999996</c:v>
                </c:pt>
                <c:pt idx="8">
                  <c:v>0.45</c:v>
                </c:pt>
                <c:pt idx="9">
                  <c:v>0</c:v>
                </c:pt>
                <c:pt idx="10">
                  <c:v>0.27810000000000001</c:v>
                </c:pt>
                <c:pt idx="11">
                  <c:v>1.6180000000000001</c:v>
                </c:pt>
                <c:pt idx="12">
                  <c:v>0.74260000000000004</c:v>
                </c:pt>
                <c:pt idx="13">
                  <c:v>1.9490000000000001</c:v>
                </c:pt>
                <c:pt idx="14">
                  <c:v>0.46</c:v>
                </c:pt>
                <c:pt idx="15">
                  <c:v>1.7949999999999999</c:v>
                </c:pt>
                <c:pt idx="16">
                  <c:v>1.0649999999999999</c:v>
                </c:pt>
                <c:pt idx="17">
                  <c:v>2.169</c:v>
                </c:pt>
                <c:pt idx="18">
                  <c:v>1.0620000000000001</c:v>
                </c:pt>
                <c:pt idx="19">
                  <c:v>1.359</c:v>
                </c:pt>
              </c:numCache>
            </c:numRef>
          </c:val>
        </c:ser>
        <c:ser>
          <c:idx val="1"/>
          <c:order val="1"/>
          <c:tx>
            <c:strRef>
              <c:f>'NEO singoli pts'!$L$81</c:f>
              <c:strCache>
                <c:ptCount val="1"/>
                <c:pt idx="0">
                  <c:v>E:T 5:1</c:v>
                </c:pt>
              </c:strCache>
            </c:strRef>
          </c:tx>
          <c:invertIfNegative val="0"/>
          <c:cat>
            <c:strRef>
              <c:f>'NEO singoli pts'!$J$82:$J$101</c:f>
              <c:strCache>
                <c:ptCount val="20"/>
                <c:pt idx="0">
                  <c:v>SG</c:v>
                </c:pt>
                <c:pt idx="1">
                  <c:v>SG+Trast</c:v>
                </c:pt>
                <c:pt idx="2">
                  <c:v>BB</c:v>
                </c:pt>
                <c:pt idx="3">
                  <c:v>BB+Trast</c:v>
                </c:pt>
                <c:pt idx="4">
                  <c:v>PT</c:v>
                </c:pt>
                <c:pt idx="5">
                  <c:v>PT+Trast</c:v>
                </c:pt>
                <c:pt idx="6">
                  <c:v>TC</c:v>
                </c:pt>
                <c:pt idx="7">
                  <c:v>TC+Trast</c:v>
                </c:pt>
                <c:pt idx="8">
                  <c:v>CF</c:v>
                </c:pt>
                <c:pt idx="9">
                  <c:v>CF+Trast</c:v>
                </c:pt>
                <c:pt idx="10">
                  <c:v>PA</c:v>
                </c:pt>
                <c:pt idx="11">
                  <c:v>PA+Trast</c:v>
                </c:pt>
                <c:pt idx="12">
                  <c:v>CM</c:v>
                </c:pt>
                <c:pt idx="13">
                  <c:v>CM+Trast</c:v>
                </c:pt>
                <c:pt idx="14">
                  <c:v>ML</c:v>
                </c:pt>
                <c:pt idx="15">
                  <c:v>ML+Trast</c:v>
                </c:pt>
                <c:pt idx="16">
                  <c:v>KAN</c:v>
                </c:pt>
                <c:pt idx="17">
                  <c:v>KAN+Trast</c:v>
                </c:pt>
                <c:pt idx="18">
                  <c:v>FR</c:v>
                </c:pt>
                <c:pt idx="19">
                  <c:v>FR+Trast</c:v>
                </c:pt>
              </c:strCache>
            </c:strRef>
          </c:cat>
          <c:val>
            <c:numRef>
              <c:f>'NEO singoli pts'!$L$82:$L$101</c:f>
              <c:numCache>
                <c:formatCode>0.00</c:formatCode>
                <c:ptCount val="20"/>
                <c:pt idx="0">
                  <c:v>0.25</c:v>
                </c:pt>
                <c:pt idx="1">
                  <c:v>1.82</c:v>
                </c:pt>
                <c:pt idx="2">
                  <c:v>40.51</c:v>
                </c:pt>
                <c:pt idx="3">
                  <c:v>42.62</c:v>
                </c:pt>
                <c:pt idx="4">
                  <c:v>0.61370000000000002</c:v>
                </c:pt>
                <c:pt idx="5">
                  <c:v>9.1189999999999998</c:v>
                </c:pt>
                <c:pt idx="6">
                  <c:v>0.80700000000000005</c:v>
                </c:pt>
                <c:pt idx="7">
                  <c:v>10.6</c:v>
                </c:pt>
                <c:pt idx="8">
                  <c:v>0.4572</c:v>
                </c:pt>
                <c:pt idx="9">
                  <c:v>0.10440000000000001</c:v>
                </c:pt>
                <c:pt idx="10">
                  <c:v>0.4572</c:v>
                </c:pt>
                <c:pt idx="11">
                  <c:v>3.944</c:v>
                </c:pt>
                <c:pt idx="12">
                  <c:v>0</c:v>
                </c:pt>
                <c:pt idx="13">
                  <c:v>1.24</c:v>
                </c:pt>
                <c:pt idx="14">
                  <c:v>0.46</c:v>
                </c:pt>
                <c:pt idx="15">
                  <c:v>3.8170000000000002</c:v>
                </c:pt>
                <c:pt idx="16">
                  <c:v>0.62</c:v>
                </c:pt>
                <c:pt idx="17">
                  <c:v>0.95440000000000003</c:v>
                </c:pt>
                <c:pt idx="18">
                  <c:v>0.74260000000000004</c:v>
                </c:pt>
                <c:pt idx="19">
                  <c:v>1.1659999999999999</c:v>
                </c:pt>
              </c:numCache>
            </c:numRef>
          </c:val>
        </c:ser>
        <c:ser>
          <c:idx val="2"/>
          <c:order val="2"/>
          <c:tx>
            <c:strRef>
              <c:f>'NEO singoli pts'!$M$81</c:f>
              <c:strCache>
                <c:ptCount val="1"/>
                <c:pt idx="0">
                  <c:v>E:T 10:1</c:v>
                </c:pt>
              </c:strCache>
            </c:strRef>
          </c:tx>
          <c:invertIfNegative val="0"/>
          <c:cat>
            <c:strRef>
              <c:f>'NEO singoli pts'!$J$82:$J$101</c:f>
              <c:strCache>
                <c:ptCount val="20"/>
                <c:pt idx="0">
                  <c:v>SG</c:v>
                </c:pt>
                <c:pt idx="1">
                  <c:v>SG+Trast</c:v>
                </c:pt>
                <c:pt idx="2">
                  <c:v>BB</c:v>
                </c:pt>
                <c:pt idx="3">
                  <c:v>BB+Trast</c:v>
                </c:pt>
                <c:pt idx="4">
                  <c:v>PT</c:v>
                </c:pt>
                <c:pt idx="5">
                  <c:v>PT+Trast</c:v>
                </c:pt>
                <c:pt idx="6">
                  <c:v>TC</c:v>
                </c:pt>
                <c:pt idx="7">
                  <c:v>TC+Trast</c:v>
                </c:pt>
                <c:pt idx="8">
                  <c:v>CF</c:v>
                </c:pt>
                <c:pt idx="9">
                  <c:v>CF+Trast</c:v>
                </c:pt>
                <c:pt idx="10">
                  <c:v>PA</c:v>
                </c:pt>
                <c:pt idx="11">
                  <c:v>PA+Trast</c:v>
                </c:pt>
                <c:pt idx="12">
                  <c:v>CM</c:v>
                </c:pt>
                <c:pt idx="13">
                  <c:v>CM+Trast</c:v>
                </c:pt>
                <c:pt idx="14">
                  <c:v>ML</c:v>
                </c:pt>
                <c:pt idx="15">
                  <c:v>ML+Trast</c:v>
                </c:pt>
                <c:pt idx="16">
                  <c:v>KAN</c:v>
                </c:pt>
                <c:pt idx="17">
                  <c:v>KAN+Trast</c:v>
                </c:pt>
                <c:pt idx="18">
                  <c:v>FR</c:v>
                </c:pt>
                <c:pt idx="19">
                  <c:v>FR+Trast</c:v>
                </c:pt>
              </c:strCache>
            </c:strRef>
          </c:cat>
          <c:val>
            <c:numRef>
              <c:f>'NEO singoli pts'!$M$82:$M$101</c:f>
              <c:numCache>
                <c:formatCode>0.00</c:formatCode>
                <c:ptCount val="20"/>
                <c:pt idx="0">
                  <c:v>0.25</c:v>
                </c:pt>
                <c:pt idx="1">
                  <c:v>15.2</c:v>
                </c:pt>
                <c:pt idx="2">
                  <c:v>52.37</c:v>
                </c:pt>
                <c:pt idx="3">
                  <c:v>54.06</c:v>
                </c:pt>
                <c:pt idx="4">
                  <c:v>0.95</c:v>
                </c:pt>
                <c:pt idx="5">
                  <c:v>17.600000000000001</c:v>
                </c:pt>
                <c:pt idx="6">
                  <c:v>0.71</c:v>
                </c:pt>
                <c:pt idx="7">
                  <c:v>4.4889999999999999</c:v>
                </c:pt>
                <c:pt idx="8">
                  <c:v>0.4572</c:v>
                </c:pt>
                <c:pt idx="9">
                  <c:v>0</c:v>
                </c:pt>
                <c:pt idx="10">
                  <c:v>0.4572</c:v>
                </c:pt>
                <c:pt idx="11">
                  <c:v>3.9689999999999999</c:v>
                </c:pt>
                <c:pt idx="12">
                  <c:v>0.45</c:v>
                </c:pt>
                <c:pt idx="13">
                  <c:v>0.60060000000000002</c:v>
                </c:pt>
                <c:pt idx="14">
                  <c:v>0.57999999999999996</c:v>
                </c:pt>
                <c:pt idx="15">
                  <c:v>3.5390000000000001</c:v>
                </c:pt>
                <c:pt idx="16">
                  <c:v>0.72409999999999997</c:v>
                </c:pt>
                <c:pt idx="17">
                  <c:v>2.7959999999999998</c:v>
                </c:pt>
                <c:pt idx="18">
                  <c:v>0.89929999999999999</c:v>
                </c:pt>
                <c:pt idx="19">
                  <c:v>3.863</c:v>
                </c:pt>
              </c:numCache>
            </c:numRef>
          </c:val>
        </c:ser>
        <c:ser>
          <c:idx val="3"/>
          <c:order val="3"/>
          <c:tx>
            <c:strRef>
              <c:f>'NEO singoli pts'!$N$81</c:f>
              <c:strCache>
                <c:ptCount val="1"/>
                <c:pt idx="0">
                  <c:v>E:T 20:1</c:v>
                </c:pt>
              </c:strCache>
            </c:strRef>
          </c:tx>
          <c:invertIfNegative val="0"/>
          <c:cat>
            <c:strRef>
              <c:f>'NEO singoli pts'!$J$82:$J$101</c:f>
              <c:strCache>
                <c:ptCount val="20"/>
                <c:pt idx="0">
                  <c:v>SG</c:v>
                </c:pt>
                <c:pt idx="1">
                  <c:v>SG+Trast</c:v>
                </c:pt>
                <c:pt idx="2">
                  <c:v>BB</c:v>
                </c:pt>
                <c:pt idx="3">
                  <c:v>BB+Trast</c:v>
                </c:pt>
                <c:pt idx="4">
                  <c:v>PT</c:v>
                </c:pt>
                <c:pt idx="5">
                  <c:v>PT+Trast</c:v>
                </c:pt>
                <c:pt idx="6">
                  <c:v>TC</c:v>
                </c:pt>
                <c:pt idx="7">
                  <c:v>TC+Trast</c:v>
                </c:pt>
                <c:pt idx="8">
                  <c:v>CF</c:v>
                </c:pt>
                <c:pt idx="9">
                  <c:v>CF+Trast</c:v>
                </c:pt>
                <c:pt idx="10">
                  <c:v>PA</c:v>
                </c:pt>
                <c:pt idx="11">
                  <c:v>PA+Trast</c:v>
                </c:pt>
                <c:pt idx="12">
                  <c:v>CM</c:v>
                </c:pt>
                <c:pt idx="13">
                  <c:v>CM+Trast</c:v>
                </c:pt>
                <c:pt idx="14">
                  <c:v>ML</c:v>
                </c:pt>
                <c:pt idx="15">
                  <c:v>ML+Trast</c:v>
                </c:pt>
                <c:pt idx="16">
                  <c:v>KAN</c:v>
                </c:pt>
                <c:pt idx="17">
                  <c:v>KAN+Trast</c:v>
                </c:pt>
                <c:pt idx="18">
                  <c:v>FR</c:v>
                </c:pt>
                <c:pt idx="19">
                  <c:v>FR+Trast</c:v>
                </c:pt>
              </c:strCache>
            </c:strRef>
          </c:cat>
          <c:val>
            <c:numRef>
              <c:f>'NEO singoli pts'!$N$82:$N$101</c:f>
              <c:numCache>
                <c:formatCode>0.00</c:formatCode>
                <c:ptCount val="20"/>
                <c:pt idx="0">
                  <c:v>0.25</c:v>
                </c:pt>
                <c:pt idx="1">
                  <c:v>28.29</c:v>
                </c:pt>
                <c:pt idx="2">
                  <c:v>62.15</c:v>
                </c:pt>
                <c:pt idx="3">
                  <c:v>63.85</c:v>
                </c:pt>
                <c:pt idx="4">
                  <c:v>1.139</c:v>
                </c:pt>
                <c:pt idx="5">
                  <c:v>19.38</c:v>
                </c:pt>
                <c:pt idx="6">
                  <c:v>0.92669999999999997</c:v>
                </c:pt>
                <c:pt idx="7">
                  <c:v>8.3829999999999991</c:v>
                </c:pt>
                <c:pt idx="8">
                  <c:v>0.4572</c:v>
                </c:pt>
                <c:pt idx="9">
                  <c:v>0</c:v>
                </c:pt>
                <c:pt idx="10">
                  <c:v>0.75849999999999995</c:v>
                </c:pt>
                <c:pt idx="11">
                  <c:v>11.07</c:v>
                </c:pt>
                <c:pt idx="12">
                  <c:v>0.89890000000000003</c:v>
                </c:pt>
                <c:pt idx="13">
                  <c:v>5.1980000000000004</c:v>
                </c:pt>
                <c:pt idx="14">
                  <c:v>0.46</c:v>
                </c:pt>
                <c:pt idx="15">
                  <c:v>6.5220000000000002</c:v>
                </c:pt>
                <c:pt idx="16">
                  <c:v>1.0920000000000001</c:v>
                </c:pt>
                <c:pt idx="17">
                  <c:v>8.41</c:v>
                </c:pt>
                <c:pt idx="18">
                  <c:v>0.53090000000000004</c:v>
                </c:pt>
                <c:pt idx="19">
                  <c:v>6.2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0777856"/>
        <c:axId val="25400064"/>
      </c:barChart>
      <c:catAx>
        <c:axId val="70777856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25400064"/>
        <c:crosses val="autoZero"/>
        <c:auto val="1"/>
        <c:lblAlgn val="ctr"/>
        <c:lblOffset val="100"/>
        <c:noMultiLvlLbl val="0"/>
      </c:catAx>
      <c:valAx>
        <c:axId val="25400064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7077785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7715861038203551"/>
          <c:y val="5.1257655293088365E-2"/>
          <c:w val="0.14228583406240886"/>
          <c:h val="0.3048920968212307"/>
        </c:manualLayout>
      </c:layout>
      <c:overlay val="0"/>
      <c:txPr>
        <a:bodyPr/>
        <a:lstStyle/>
        <a:p>
          <a:pPr>
            <a:defRPr b="1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Grafici NEO VV e HH x FIG Suppl'!$D$45</c:f>
              <c:strCache>
                <c:ptCount val="1"/>
                <c:pt idx="0">
                  <c:v>E:T 2:1</c:v>
                </c:pt>
              </c:strCache>
            </c:strRef>
          </c:tx>
          <c:invertIfNegative val="0"/>
          <c:cat>
            <c:strRef>
              <c:f>'Grafici NEO VV e HH x FIG Suppl'!$C$46:$C$53</c:f>
              <c:strCache>
                <c:ptCount val="8"/>
                <c:pt idx="0">
                  <c:v>FG</c:v>
                </c:pt>
                <c:pt idx="1">
                  <c:v>FG+Trast</c:v>
                </c:pt>
                <c:pt idx="2">
                  <c:v>LR</c:v>
                </c:pt>
                <c:pt idx="3">
                  <c:v>LR+Trast</c:v>
                </c:pt>
                <c:pt idx="4">
                  <c:v>KAN</c:v>
                </c:pt>
                <c:pt idx="5">
                  <c:v>KAN+Trast</c:v>
                </c:pt>
                <c:pt idx="6">
                  <c:v>ML</c:v>
                </c:pt>
                <c:pt idx="7">
                  <c:v>ML+Trast</c:v>
                </c:pt>
              </c:strCache>
            </c:strRef>
          </c:cat>
          <c:val>
            <c:numRef>
              <c:f>'Grafici NEO VV e HH x FIG Suppl'!$D$46:$D$53</c:f>
              <c:numCache>
                <c:formatCode>0.00</c:formatCode>
                <c:ptCount val="8"/>
                <c:pt idx="0">
                  <c:v>6.85</c:v>
                </c:pt>
                <c:pt idx="1">
                  <c:v>11</c:v>
                </c:pt>
                <c:pt idx="2">
                  <c:v>0.36520000000000002</c:v>
                </c:pt>
                <c:pt idx="3">
                  <c:v>7.9560000000000004</c:v>
                </c:pt>
                <c:pt idx="4">
                  <c:v>1.0649999999999999</c:v>
                </c:pt>
                <c:pt idx="5">
                  <c:v>2.169</c:v>
                </c:pt>
                <c:pt idx="6">
                  <c:v>0</c:v>
                </c:pt>
                <c:pt idx="7">
                  <c:v>1.7949999999999999</c:v>
                </c:pt>
              </c:numCache>
            </c:numRef>
          </c:val>
        </c:ser>
        <c:ser>
          <c:idx val="1"/>
          <c:order val="1"/>
          <c:tx>
            <c:strRef>
              <c:f>'Grafici NEO VV e HH x FIG Suppl'!$E$45</c:f>
              <c:strCache>
                <c:ptCount val="1"/>
                <c:pt idx="0">
                  <c:v>E:T 5:1</c:v>
                </c:pt>
              </c:strCache>
            </c:strRef>
          </c:tx>
          <c:invertIfNegative val="0"/>
          <c:cat>
            <c:strRef>
              <c:f>'Grafici NEO VV e HH x FIG Suppl'!$C$46:$C$53</c:f>
              <c:strCache>
                <c:ptCount val="8"/>
                <c:pt idx="0">
                  <c:v>FG</c:v>
                </c:pt>
                <c:pt idx="1">
                  <c:v>FG+Trast</c:v>
                </c:pt>
                <c:pt idx="2">
                  <c:v>LR</c:v>
                </c:pt>
                <c:pt idx="3">
                  <c:v>LR+Trast</c:v>
                </c:pt>
                <c:pt idx="4">
                  <c:v>KAN</c:v>
                </c:pt>
                <c:pt idx="5">
                  <c:v>KAN+Trast</c:v>
                </c:pt>
                <c:pt idx="6">
                  <c:v>ML</c:v>
                </c:pt>
                <c:pt idx="7">
                  <c:v>ML+Trast</c:v>
                </c:pt>
              </c:strCache>
            </c:strRef>
          </c:cat>
          <c:val>
            <c:numRef>
              <c:f>'Grafici NEO VV e HH x FIG Suppl'!$E$46:$E$53</c:f>
              <c:numCache>
                <c:formatCode>0.00</c:formatCode>
                <c:ptCount val="8"/>
                <c:pt idx="0">
                  <c:v>13.27</c:v>
                </c:pt>
                <c:pt idx="1">
                  <c:v>18.420000000000002</c:v>
                </c:pt>
                <c:pt idx="2">
                  <c:v>2.1520000000000001</c:v>
                </c:pt>
                <c:pt idx="3">
                  <c:v>13.63</c:v>
                </c:pt>
                <c:pt idx="4">
                  <c:v>0.62</c:v>
                </c:pt>
                <c:pt idx="5">
                  <c:v>0.95440000000000003</c:v>
                </c:pt>
                <c:pt idx="6">
                  <c:v>0</c:v>
                </c:pt>
                <c:pt idx="7">
                  <c:v>3.8170000000000002</c:v>
                </c:pt>
              </c:numCache>
            </c:numRef>
          </c:val>
        </c:ser>
        <c:ser>
          <c:idx val="2"/>
          <c:order val="2"/>
          <c:tx>
            <c:strRef>
              <c:f>'Grafici NEO VV e HH x FIG Suppl'!$F$45</c:f>
              <c:strCache>
                <c:ptCount val="1"/>
                <c:pt idx="0">
                  <c:v>E:T 10:1</c:v>
                </c:pt>
              </c:strCache>
            </c:strRef>
          </c:tx>
          <c:invertIfNegative val="0"/>
          <c:cat>
            <c:strRef>
              <c:f>'Grafici NEO VV e HH x FIG Suppl'!$C$46:$C$53</c:f>
              <c:strCache>
                <c:ptCount val="8"/>
                <c:pt idx="0">
                  <c:v>FG</c:v>
                </c:pt>
                <c:pt idx="1">
                  <c:v>FG+Trast</c:v>
                </c:pt>
                <c:pt idx="2">
                  <c:v>LR</c:v>
                </c:pt>
                <c:pt idx="3">
                  <c:v>LR+Trast</c:v>
                </c:pt>
                <c:pt idx="4">
                  <c:v>KAN</c:v>
                </c:pt>
                <c:pt idx="5">
                  <c:v>KAN+Trast</c:v>
                </c:pt>
                <c:pt idx="6">
                  <c:v>ML</c:v>
                </c:pt>
                <c:pt idx="7">
                  <c:v>ML+Trast</c:v>
                </c:pt>
              </c:strCache>
            </c:strRef>
          </c:cat>
          <c:val>
            <c:numRef>
              <c:f>'Grafici NEO VV e HH x FIG Suppl'!$F$46:$F$53</c:f>
              <c:numCache>
                <c:formatCode>0.00</c:formatCode>
                <c:ptCount val="8"/>
                <c:pt idx="0">
                  <c:v>10.54</c:v>
                </c:pt>
                <c:pt idx="1">
                  <c:v>25.42</c:v>
                </c:pt>
                <c:pt idx="2">
                  <c:v>4.7089999999999996</c:v>
                </c:pt>
                <c:pt idx="3">
                  <c:v>18.41</c:v>
                </c:pt>
                <c:pt idx="4">
                  <c:v>0.72409999999999997</c:v>
                </c:pt>
                <c:pt idx="5">
                  <c:v>2.7959999999999998</c:v>
                </c:pt>
                <c:pt idx="6">
                  <c:v>0.58150000000000002</c:v>
                </c:pt>
                <c:pt idx="7">
                  <c:v>3.5390000000000001</c:v>
                </c:pt>
              </c:numCache>
            </c:numRef>
          </c:val>
        </c:ser>
        <c:ser>
          <c:idx val="3"/>
          <c:order val="3"/>
          <c:tx>
            <c:strRef>
              <c:f>'Grafici NEO VV e HH x FIG Suppl'!$G$45</c:f>
              <c:strCache>
                <c:ptCount val="1"/>
                <c:pt idx="0">
                  <c:v>E:T 20:1</c:v>
                </c:pt>
              </c:strCache>
            </c:strRef>
          </c:tx>
          <c:invertIfNegative val="0"/>
          <c:cat>
            <c:strRef>
              <c:f>'Grafici NEO VV e HH x FIG Suppl'!$C$46:$C$53</c:f>
              <c:strCache>
                <c:ptCount val="8"/>
                <c:pt idx="0">
                  <c:v>FG</c:v>
                </c:pt>
                <c:pt idx="1">
                  <c:v>FG+Trast</c:v>
                </c:pt>
                <c:pt idx="2">
                  <c:v>LR</c:v>
                </c:pt>
                <c:pt idx="3">
                  <c:v>LR+Trast</c:v>
                </c:pt>
                <c:pt idx="4">
                  <c:v>KAN</c:v>
                </c:pt>
                <c:pt idx="5">
                  <c:v>KAN+Trast</c:v>
                </c:pt>
                <c:pt idx="6">
                  <c:v>ML</c:v>
                </c:pt>
                <c:pt idx="7">
                  <c:v>ML+Trast</c:v>
                </c:pt>
              </c:strCache>
            </c:strRef>
          </c:cat>
          <c:val>
            <c:numRef>
              <c:f>'Grafici NEO VV e HH x FIG Suppl'!$G$46:$G$53</c:f>
              <c:numCache>
                <c:formatCode>0.00</c:formatCode>
                <c:ptCount val="8"/>
                <c:pt idx="0">
                  <c:v>17.3</c:v>
                </c:pt>
                <c:pt idx="1">
                  <c:v>38</c:v>
                </c:pt>
                <c:pt idx="2">
                  <c:v>7.6870000000000003</c:v>
                </c:pt>
                <c:pt idx="3">
                  <c:v>23.34</c:v>
                </c:pt>
                <c:pt idx="4">
                  <c:v>1.0920000000000001</c:v>
                </c:pt>
                <c:pt idx="5">
                  <c:v>8.41</c:v>
                </c:pt>
                <c:pt idx="6">
                  <c:v>0</c:v>
                </c:pt>
                <c:pt idx="7">
                  <c:v>6.5220000000000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5115264"/>
        <c:axId val="25117056"/>
      </c:barChart>
      <c:catAx>
        <c:axId val="2511526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25117056"/>
        <c:crosses val="autoZero"/>
        <c:auto val="1"/>
        <c:lblAlgn val="ctr"/>
        <c:lblOffset val="100"/>
        <c:noMultiLvlLbl val="0"/>
      </c:catAx>
      <c:valAx>
        <c:axId val="25117056"/>
        <c:scaling>
          <c:orientation val="minMax"/>
          <c:max val="70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25115264"/>
        <c:crosses val="autoZero"/>
        <c:crossBetween val="between"/>
        <c:majorUnit val="10"/>
      </c:valAx>
    </c:plotArea>
    <c:legend>
      <c:legendPos val="r"/>
      <c:layout>
        <c:manualLayout>
          <c:xMode val="edge"/>
          <c:yMode val="edge"/>
          <c:x val="0.65703477690288714"/>
          <c:y val="5.5887284922717995E-2"/>
          <c:w val="0.14852077865266841"/>
          <c:h val="0.31415135608048994"/>
        </c:manualLayout>
      </c:layout>
      <c:overlay val="0"/>
      <c:txPr>
        <a:bodyPr/>
        <a:lstStyle/>
        <a:p>
          <a:pPr>
            <a:defRPr b="1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Grafici NEO VV e HH x FIG Suppl'!$M$45</c:f>
              <c:strCache>
                <c:ptCount val="1"/>
                <c:pt idx="0">
                  <c:v>E:T 2:1</c:v>
                </c:pt>
              </c:strCache>
            </c:strRef>
          </c:tx>
          <c:invertIfNegative val="0"/>
          <c:cat>
            <c:strRef>
              <c:f>'Grafici NEO VV e HH x FIG Suppl'!$L$46:$L$51</c:f>
              <c:strCache>
                <c:ptCount val="6"/>
                <c:pt idx="0">
                  <c:v>FG</c:v>
                </c:pt>
                <c:pt idx="1">
                  <c:v>FG+Trast</c:v>
                </c:pt>
                <c:pt idx="2">
                  <c:v>LR</c:v>
                </c:pt>
                <c:pt idx="3">
                  <c:v>LR+Trast</c:v>
                </c:pt>
                <c:pt idx="4">
                  <c:v>CV</c:v>
                </c:pt>
                <c:pt idx="5">
                  <c:v>CV+Trast</c:v>
                </c:pt>
              </c:strCache>
            </c:strRef>
          </c:cat>
          <c:val>
            <c:numRef>
              <c:f>'Grafici NEO VV e HH x FIG Suppl'!$M$46:$M$51</c:f>
              <c:numCache>
                <c:formatCode>0.00</c:formatCode>
                <c:ptCount val="6"/>
                <c:pt idx="0">
                  <c:v>6.5</c:v>
                </c:pt>
                <c:pt idx="1">
                  <c:v>9.75</c:v>
                </c:pt>
                <c:pt idx="2">
                  <c:v>0.36520000000000002</c:v>
                </c:pt>
                <c:pt idx="3">
                  <c:v>7.9560000000000004</c:v>
                </c:pt>
                <c:pt idx="4">
                  <c:v>0.74260000000000004</c:v>
                </c:pt>
                <c:pt idx="5">
                  <c:v>1.9490000000000001</c:v>
                </c:pt>
              </c:numCache>
            </c:numRef>
          </c:val>
        </c:ser>
        <c:ser>
          <c:idx val="1"/>
          <c:order val="1"/>
          <c:tx>
            <c:strRef>
              <c:f>'Grafici NEO VV e HH x FIG Suppl'!$N$45</c:f>
              <c:strCache>
                <c:ptCount val="1"/>
                <c:pt idx="0">
                  <c:v>E:T 5:1</c:v>
                </c:pt>
              </c:strCache>
            </c:strRef>
          </c:tx>
          <c:invertIfNegative val="0"/>
          <c:cat>
            <c:strRef>
              <c:f>'Grafici NEO VV e HH x FIG Suppl'!$L$46:$L$51</c:f>
              <c:strCache>
                <c:ptCount val="6"/>
                <c:pt idx="0">
                  <c:v>FG</c:v>
                </c:pt>
                <c:pt idx="1">
                  <c:v>FG+Trast</c:v>
                </c:pt>
                <c:pt idx="2">
                  <c:v>LR</c:v>
                </c:pt>
                <c:pt idx="3">
                  <c:v>LR+Trast</c:v>
                </c:pt>
                <c:pt idx="4">
                  <c:v>CV</c:v>
                </c:pt>
                <c:pt idx="5">
                  <c:v>CV+Trast</c:v>
                </c:pt>
              </c:strCache>
            </c:strRef>
          </c:cat>
          <c:val>
            <c:numRef>
              <c:f>'Grafici NEO VV e HH x FIG Suppl'!$N$46:$N$51</c:f>
              <c:numCache>
                <c:formatCode>0.00</c:formatCode>
                <c:ptCount val="6"/>
                <c:pt idx="0">
                  <c:v>12.4</c:v>
                </c:pt>
                <c:pt idx="1">
                  <c:v>19.43</c:v>
                </c:pt>
                <c:pt idx="2">
                  <c:v>2.1520000000000001</c:v>
                </c:pt>
                <c:pt idx="3">
                  <c:v>13.63</c:v>
                </c:pt>
                <c:pt idx="4">
                  <c:v>0</c:v>
                </c:pt>
                <c:pt idx="5">
                  <c:v>1.24</c:v>
                </c:pt>
              </c:numCache>
            </c:numRef>
          </c:val>
        </c:ser>
        <c:ser>
          <c:idx val="2"/>
          <c:order val="2"/>
          <c:tx>
            <c:strRef>
              <c:f>'Grafici NEO VV e HH x FIG Suppl'!$O$45</c:f>
              <c:strCache>
                <c:ptCount val="1"/>
                <c:pt idx="0">
                  <c:v>E:T 10:1</c:v>
                </c:pt>
              </c:strCache>
            </c:strRef>
          </c:tx>
          <c:invertIfNegative val="0"/>
          <c:cat>
            <c:strRef>
              <c:f>'Grafici NEO VV e HH x FIG Suppl'!$L$46:$L$51</c:f>
              <c:strCache>
                <c:ptCount val="6"/>
                <c:pt idx="0">
                  <c:v>FG</c:v>
                </c:pt>
                <c:pt idx="1">
                  <c:v>FG+Trast</c:v>
                </c:pt>
                <c:pt idx="2">
                  <c:v>LR</c:v>
                </c:pt>
                <c:pt idx="3">
                  <c:v>LR+Trast</c:v>
                </c:pt>
                <c:pt idx="4">
                  <c:v>CV</c:v>
                </c:pt>
                <c:pt idx="5">
                  <c:v>CV+Trast</c:v>
                </c:pt>
              </c:strCache>
            </c:strRef>
          </c:cat>
          <c:val>
            <c:numRef>
              <c:f>'Grafici NEO VV e HH x FIG Suppl'!$O$46:$O$51</c:f>
              <c:numCache>
                <c:formatCode>0.00</c:formatCode>
                <c:ptCount val="6"/>
                <c:pt idx="0">
                  <c:v>10.45</c:v>
                </c:pt>
                <c:pt idx="1">
                  <c:v>25.06</c:v>
                </c:pt>
                <c:pt idx="2">
                  <c:v>4.7089999999999996</c:v>
                </c:pt>
                <c:pt idx="3">
                  <c:v>18.41</c:v>
                </c:pt>
                <c:pt idx="4">
                  <c:v>0.44800000000000001</c:v>
                </c:pt>
                <c:pt idx="5">
                  <c:v>0.60060000000000002</c:v>
                </c:pt>
              </c:numCache>
            </c:numRef>
          </c:val>
        </c:ser>
        <c:ser>
          <c:idx val="3"/>
          <c:order val="3"/>
          <c:tx>
            <c:strRef>
              <c:f>'Grafici NEO VV e HH x FIG Suppl'!$P$45</c:f>
              <c:strCache>
                <c:ptCount val="1"/>
                <c:pt idx="0">
                  <c:v>E:T 20:1</c:v>
                </c:pt>
              </c:strCache>
            </c:strRef>
          </c:tx>
          <c:invertIfNegative val="0"/>
          <c:cat>
            <c:strRef>
              <c:f>'Grafici NEO VV e HH x FIG Suppl'!$L$46:$L$51</c:f>
              <c:strCache>
                <c:ptCount val="6"/>
                <c:pt idx="0">
                  <c:v>FG</c:v>
                </c:pt>
                <c:pt idx="1">
                  <c:v>FG+Trast</c:v>
                </c:pt>
                <c:pt idx="2">
                  <c:v>LR</c:v>
                </c:pt>
                <c:pt idx="3">
                  <c:v>LR+Trast</c:v>
                </c:pt>
                <c:pt idx="4">
                  <c:v>CV</c:v>
                </c:pt>
                <c:pt idx="5">
                  <c:v>CV+Trast</c:v>
                </c:pt>
              </c:strCache>
            </c:strRef>
          </c:cat>
          <c:val>
            <c:numRef>
              <c:f>'Grafici NEO VV e HH x FIG Suppl'!$P$46:$P$51</c:f>
              <c:numCache>
                <c:formatCode>0.00</c:formatCode>
                <c:ptCount val="6"/>
                <c:pt idx="0">
                  <c:v>15.27</c:v>
                </c:pt>
                <c:pt idx="1">
                  <c:v>39.44</c:v>
                </c:pt>
                <c:pt idx="2">
                  <c:v>7.6870000000000003</c:v>
                </c:pt>
                <c:pt idx="3">
                  <c:v>25.23</c:v>
                </c:pt>
                <c:pt idx="4">
                  <c:v>0.89890000000000003</c:v>
                </c:pt>
                <c:pt idx="5">
                  <c:v>5.19800000000000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5540864"/>
        <c:axId val="25546752"/>
      </c:barChart>
      <c:catAx>
        <c:axId val="2554086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 rot="-1980000" vert="horz"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25546752"/>
        <c:crosses val="autoZero"/>
        <c:auto val="1"/>
        <c:lblAlgn val="ctr"/>
        <c:lblOffset val="100"/>
        <c:noMultiLvlLbl val="0"/>
      </c:catAx>
      <c:valAx>
        <c:axId val="25546752"/>
        <c:scaling>
          <c:orientation val="minMax"/>
          <c:max val="70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25540864"/>
        <c:crosses val="autoZero"/>
        <c:crossBetween val="between"/>
        <c:majorUnit val="10"/>
      </c:valAx>
    </c:plotArea>
    <c:legend>
      <c:legendPos val="r"/>
      <c:layout>
        <c:manualLayout>
          <c:xMode val="edge"/>
          <c:yMode val="edge"/>
          <c:x val="0.62420564565938363"/>
          <c:y val="4.19983960338291E-2"/>
          <c:w val="0.14729333420099347"/>
          <c:h val="0.31415135608048994"/>
        </c:manualLayout>
      </c:layout>
      <c:overlay val="0"/>
      <c:txPr>
        <a:bodyPr/>
        <a:lstStyle/>
        <a:p>
          <a:pPr>
            <a:defRPr b="1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o 4"/>
          <p:cNvGrpSpPr/>
          <p:nvPr/>
        </p:nvGrpSpPr>
        <p:grpSpPr>
          <a:xfrm>
            <a:off x="109919" y="44624"/>
            <a:ext cx="9740154" cy="6912768"/>
            <a:chOff x="109919" y="44624"/>
            <a:chExt cx="9740154" cy="6912768"/>
          </a:xfrm>
        </p:grpSpPr>
        <p:grpSp>
          <p:nvGrpSpPr>
            <p:cNvPr id="3" name="Gruppo 2"/>
            <p:cNvGrpSpPr/>
            <p:nvPr/>
          </p:nvGrpSpPr>
          <p:grpSpPr>
            <a:xfrm>
              <a:off x="166073" y="44624"/>
              <a:ext cx="9684000" cy="5580000"/>
              <a:chOff x="166073" y="44624"/>
              <a:chExt cx="9813332" cy="6487616"/>
            </a:xfrm>
          </p:grpSpPr>
          <p:graphicFrame>
            <p:nvGraphicFramePr>
              <p:cNvPr id="10" name="Grafico 9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202602683"/>
                  </p:ext>
                </p:extLst>
              </p:nvPr>
            </p:nvGraphicFramePr>
            <p:xfrm>
              <a:off x="4610957" y="634985"/>
              <a:ext cx="5133975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8" name="CasellaDiTesto 7"/>
              <p:cNvSpPr txBox="1"/>
              <p:nvPr/>
            </p:nvSpPr>
            <p:spPr>
              <a:xfrm>
                <a:off x="1442605" y="414422"/>
                <a:ext cx="194421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400" b="1" dirty="0" err="1" smtClean="0">
                    <a:latin typeface="Times New Roman" pitchFamily="18" charset="0"/>
                    <a:cs typeface="Times New Roman" pitchFamily="18" charset="0"/>
                  </a:rPr>
                  <a:t>Fc</a:t>
                </a:r>
                <a:r>
                  <a:rPr lang="el-GR" sz="1400" b="1" dirty="0" smtClean="0">
                    <a:latin typeface="Times New Roman" pitchFamily="18" charset="0"/>
                    <a:cs typeface="Times New Roman" pitchFamily="18" charset="0"/>
                  </a:rPr>
                  <a:t>γ</a:t>
                </a:r>
                <a:r>
                  <a:rPr lang="it-IT" sz="1400" b="1" dirty="0" smtClean="0">
                    <a:latin typeface="Times New Roman" pitchFamily="18" charset="0"/>
                    <a:cs typeface="Times New Roman" pitchFamily="18" charset="0"/>
                  </a:rPr>
                  <a:t>RIIIA V/V </a:t>
                </a:r>
                <a:r>
                  <a:rPr lang="it-IT" sz="1400" b="1" dirty="0" err="1" smtClean="0">
                    <a:latin typeface="Times New Roman" pitchFamily="18" charset="0"/>
                    <a:cs typeface="Times New Roman" pitchFamily="18" charset="0"/>
                  </a:rPr>
                  <a:t>carriers</a:t>
                </a:r>
                <a:endParaRPr lang="it-IT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4" name="CasellaDiTesto 13"/>
              <p:cNvSpPr txBox="1"/>
              <p:nvPr/>
            </p:nvSpPr>
            <p:spPr>
              <a:xfrm>
                <a:off x="6123125" y="404664"/>
                <a:ext cx="172819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400" b="1" dirty="0" err="1" smtClean="0">
                    <a:latin typeface="Times New Roman" pitchFamily="18" charset="0"/>
                    <a:cs typeface="Times New Roman" pitchFamily="18" charset="0"/>
                  </a:rPr>
                  <a:t>Fc</a:t>
                </a:r>
                <a:r>
                  <a:rPr lang="el-GR" sz="1400" b="1" dirty="0" smtClean="0">
                    <a:latin typeface="Times New Roman" pitchFamily="18" charset="0"/>
                    <a:cs typeface="Times New Roman" pitchFamily="18" charset="0"/>
                  </a:rPr>
                  <a:t>γ</a:t>
                </a:r>
                <a:r>
                  <a:rPr lang="it-IT" sz="1400" b="1" dirty="0" smtClean="0">
                    <a:latin typeface="Times New Roman" pitchFamily="18" charset="0"/>
                    <a:cs typeface="Times New Roman" pitchFamily="18" charset="0"/>
                  </a:rPr>
                  <a:t>RIIIA F </a:t>
                </a:r>
                <a:r>
                  <a:rPr lang="it-IT" sz="1400" b="1" dirty="0" err="1" smtClean="0">
                    <a:latin typeface="Times New Roman" pitchFamily="18" charset="0"/>
                    <a:cs typeface="Times New Roman" pitchFamily="18" charset="0"/>
                  </a:rPr>
                  <a:t>carriers</a:t>
                </a:r>
                <a:endParaRPr lang="it-IT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" name="CasellaDiTesto 14"/>
              <p:cNvSpPr txBox="1"/>
              <p:nvPr/>
            </p:nvSpPr>
            <p:spPr>
              <a:xfrm>
                <a:off x="1442605" y="3481263"/>
                <a:ext cx="244827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400" b="1" dirty="0" err="1">
                    <a:latin typeface="Times New Roman" pitchFamily="18" charset="0"/>
                    <a:cs typeface="Times New Roman" pitchFamily="18" charset="0"/>
                  </a:rPr>
                  <a:t>Fc</a:t>
                </a:r>
                <a:r>
                  <a:rPr lang="el-GR" sz="1400" b="1" dirty="0">
                    <a:latin typeface="Times New Roman" pitchFamily="18" charset="0"/>
                    <a:cs typeface="Times New Roman" pitchFamily="18" charset="0"/>
                  </a:rPr>
                  <a:t>γ</a:t>
                </a:r>
                <a:r>
                  <a:rPr lang="it-IT" sz="1400" b="1" dirty="0" smtClean="0">
                    <a:latin typeface="Times New Roman" pitchFamily="18" charset="0"/>
                    <a:cs typeface="Times New Roman" pitchFamily="18" charset="0"/>
                  </a:rPr>
                  <a:t>RIIA H/H </a:t>
                </a:r>
                <a:r>
                  <a:rPr lang="it-IT" sz="1400" b="1" dirty="0" err="1" smtClean="0">
                    <a:latin typeface="Times New Roman" pitchFamily="18" charset="0"/>
                    <a:cs typeface="Times New Roman" pitchFamily="18" charset="0"/>
                  </a:rPr>
                  <a:t>carriers</a:t>
                </a:r>
                <a:endParaRPr lang="it-IT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6" name="CasellaDiTesto 15"/>
              <p:cNvSpPr txBox="1"/>
              <p:nvPr/>
            </p:nvSpPr>
            <p:spPr>
              <a:xfrm>
                <a:off x="6123125" y="3438525"/>
                <a:ext cx="187220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400" b="1" dirty="0" err="1">
                    <a:latin typeface="Times New Roman" pitchFamily="18" charset="0"/>
                    <a:cs typeface="Times New Roman" pitchFamily="18" charset="0"/>
                  </a:rPr>
                  <a:t>Fc</a:t>
                </a:r>
                <a:r>
                  <a:rPr lang="el-GR" sz="1400" b="1" dirty="0">
                    <a:latin typeface="Times New Roman" pitchFamily="18" charset="0"/>
                    <a:cs typeface="Times New Roman" pitchFamily="18" charset="0"/>
                  </a:rPr>
                  <a:t>γ</a:t>
                </a:r>
                <a:r>
                  <a:rPr lang="it-IT" sz="1400" b="1" smtClean="0">
                    <a:latin typeface="Times New Roman" pitchFamily="18" charset="0"/>
                    <a:cs typeface="Times New Roman" pitchFamily="18" charset="0"/>
                  </a:rPr>
                  <a:t>RIIA </a:t>
                </a:r>
                <a:r>
                  <a:rPr lang="it-IT" sz="1400" b="1" dirty="0">
                    <a:latin typeface="Times New Roman" pitchFamily="18" charset="0"/>
                    <a:cs typeface="Times New Roman" pitchFamily="18" charset="0"/>
                  </a:rPr>
                  <a:t>R</a:t>
                </a:r>
                <a:r>
                  <a:rPr lang="it-IT" sz="1400" b="1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it-IT" sz="1400" b="1" dirty="0" err="1" smtClean="0">
                    <a:latin typeface="Times New Roman" pitchFamily="18" charset="0"/>
                    <a:cs typeface="Times New Roman" pitchFamily="18" charset="0"/>
                  </a:rPr>
                  <a:t>carriers</a:t>
                </a:r>
                <a:endParaRPr lang="it-IT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graphicFrame>
            <p:nvGraphicFramePr>
              <p:cNvPr id="18" name="Grafico 1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1334944"/>
                  </p:ext>
                </p:extLst>
              </p:nvPr>
            </p:nvGraphicFramePr>
            <p:xfrm>
              <a:off x="4493005" y="3788278"/>
              <a:ext cx="54864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2" name="CasellaDiTesto 1"/>
              <p:cNvSpPr txBox="1"/>
              <p:nvPr/>
            </p:nvSpPr>
            <p:spPr>
              <a:xfrm>
                <a:off x="3682236" y="44624"/>
                <a:ext cx="18002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600" b="1" dirty="0" smtClean="0">
                    <a:latin typeface="Times New Roman" pitchFamily="18" charset="0"/>
                    <a:cs typeface="Times New Roman" pitchFamily="18" charset="0"/>
                  </a:rPr>
                  <a:t>NEO PATIENTS</a:t>
                </a:r>
                <a:endParaRPr lang="it-IT" sz="16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9" name="CasellaDiTesto 18"/>
              <p:cNvSpPr txBox="1"/>
              <p:nvPr/>
            </p:nvSpPr>
            <p:spPr>
              <a:xfrm rot="16200000">
                <a:off x="-611005" y="4458017"/>
                <a:ext cx="20162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 </a:t>
                </a:r>
                <a:r>
                  <a:rPr lang="it-IT" sz="1000" b="1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1</a:t>
                </a:r>
                <a:r>
                  <a:rPr lang="it-IT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r </a:t>
                </a:r>
                <a:r>
                  <a:rPr lang="it-IT" sz="10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pecific</a:t>
                </a:r>
                <a:r>
                  <a:rPr lang="it-IT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release</a:t>
                </a:r>
                <a:endParaRPr lang="it-IT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CasellaDiTesto 19"/>
              <p:cNvSpPr txBox="1"/>
              <p:nvPr/>
            </p:nvSpPr>
            <p:spPr>
              <a:xfrm rot="16200000">
                <a:off x="-667632" y="1298502"/>
                <a:ext cx="2016224" cy="3488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it-IT" sz="1000" b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it-IT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 </a:t>
                </a:r>
                <a:r>
                  <a:rPr lang="it-IT" sz="1000" b="1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1</a:t>
                </a:r>
                <a:r>
                  <a:rPr lang="it-IT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r </a:t>
                </a:r>
                <a:r>
                  <a:rPr lang="it-IT" sz="10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pecific</a:t>
                </a:r>
                <a:r>
                  <a:rPr lang="it-IT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release</a:t>
                </a:r>
                <a:endParaRPr lang="it-IT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CasellaDiTesto 20"/>
              <p:cNvSpPr txBox="1"/>
              <p:nvPr/>
            </p:nvSpPr>
            <p:spPr>
              <a:xfrm rot="16200000">
                <a:off x="3388745" y="4458017"/>
                <a:ext cx="20162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 </a:t>
                </a:r>
                <a:r>
                  <a:rPr lang="it-IT" sz="1000" b="1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1</a:t>
                </a:r>
                <a:r>
                  <a:rPr lang="it-IT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r </a:t>
                </a:r>
                <a:r>
                  <a:rPr lang="it-IT" sz="10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pecific</a:t>
                </a:r>
                <a:r>
                  <a:rPr lang="it-IT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release</a:t>
                </a:r>
                <a:endParaRPr lang="it-IT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CasellaDiTesto 21"/>
              <p:cNvSpPr txBox="1"/>
              <p:nvPr/>
            </p:nvSpPr>
            <p:spPr>
              <a:xfrm rot="16200000">
                <a:off x="3445936" y="1298502"/>
                <a:ext cx="2016224" cy="3488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it-IT" sz="1000" b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it-IT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 </a:t>
                </a:r>
                <a:r>
                  <a:rPr lang="it-IT" sz="1000" b="1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1</a:t>
                </a:r>
                <a:r>
                  <a:rPr lang="it-IT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r </a:t>
                </a:r>
                <a:r>
                  <a:rPr lang="it-IT" sz="10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pecific</a:t>
                </a:r>
                <a:r>
                  <a:rPr lang="it-IT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release</a:t>
                </a:r>
                <a:endParaRPr lang="it-IT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" name="CasellaDiTesto 3"/>
              <p:cNvSpPr txBox="1"/>
              <p:nvPr/>
            </p:nvSpPr>
            <p:spPr>
              <a:xfrm>
                <a:off x="251520" y="449280"/>
                <a:ext cx="4441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400" b="1" dirty="0" smtClean="0">
                    <a:latin typeface="Times New Roman" pitchFamily="18" charset="0"/>
                    <a:cs typeface="Times New Roman" pitchFamily="18" charset="0"/>
                  </a:rPr>
                  <a:t>A</a:t>
                </a:r>
                <a:endParaRPr lang="it-IT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3" name="CasellaDiTesto 22"/>
              <p:cNvSpPr txBox="1"/>
              <p:nvPr/>
            </p:nvSpPr>
            <p:spPr>
              <a:xfrm>
                <a:off x="251520" y="3553271"/>
                <a:ext cx="4441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400" b="1" dirty="0" smtClean="0">
                    <a:latin typeface="Times New Roman" pitchFamily="18" charset="0"/>
                    <a:cs typeface="Times New Roman" pitchFamily="18" charset="0"/>
                  </a:rPr>
                  <a:t>C</a:t>
                </a:r>
                <a:endParaRPr lang="it-IT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4" name="CasellaDiTesto 23"/>
              <p:cNvSpPr txBox="1"/>
              <p:nvPr/>
            </p:nvSpPr>
            <p:spPr>
              <a:xfrm>
                <a:off x="4415838" y="404664"/>
                <a:ext cx="4441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400" b="1" dirty="0">
                    <a:latin typeface="Times New Roman" pitchFamily="18" charset="0"/>
                    <a:cs typeface="Times New Roman" pitchFamily="18" charset="0"/>
                  </a:rPr>
                  <a:t>B</a:t>
                </a:r>
              </a:p>
            </p:txBody>
          </p:sp>
          <p:sp>
            <p:nvSpPr>
              <p:cNvPr id="25" name="CasellaDiTesto 24"/>
              <p:cNvSpPr txBox="1"/>
              <p:nvPr/>
            </p:nvSpPr>
            <p:spPr>
              <a:xfrm>
                <a:off x="4283968" y="3575305"/>
                <a:ext cx="4441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400" b="1" dirty="0">
                    <a:latin typeface="Times New Roman" pitchFamily="18" charset="0"/>
                    <a:cs typeface="Times New Roman" pitchFamily="18" charset="0"/>
                  </a:rPr>
                  <a:t>D</a:t>
                </a:r>
              </a:p>
            </p:txBody>
          </p:sp>
          <p:graphicFrame>
            <p:nvGraphicFramePr>
              <p:cNvPr id="26" name="Grafico 2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206247496"/>
                  </p:ext>
                </p:extLst>
              </p:nvPr>
            </p:nvGraphicFramePr>
            <p:xfrm>
              <a:off x="481257" y="734939"/>
              <a:ext cx="452755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27" name="Grafico 2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108880251"/>
                  </p:ext>
                </p:extLst>
              </p:nvPr>
            </p:nvGraphicFramePr>
            <p:xfrm>
              <a:off x="473617" y="3789040"/>
              <a:ext cx="45593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</p:grpSp>
        <p:sp>
          <p:nvSpPr>
            <p:cNvPr id="29" name="Rettangolo 28"/>
            <p:cNvSpPr/>
            <p:nvPr/>
          </p:nvSpPr>
          <p:spPr>
            <a:xfrm>
              <a:off x="109919" y="5633953"/>
              <a:ext cx="8926577" cy="132343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sal and </a:t>
              </a:r>
              <a:r>
                <a:rPr lang="en-GB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stuzumab</a:t>
              </a:r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mediated cytotoxicity of MCF-7 cell line induced by PBMCs derived from the NEO individual patients according to the </a:t>
              </a:r>
              <a:r>
                <a:rPr lang="en-GB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cγRIIIA</a:t>
              </a:r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58V&gt;F and </a:t>
              </a:r>
              <a:r>
                <a:rPr lang="en-GB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cγRIIA</a:t>
              </a:r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31R&gt;H polymorphisms. </a:t>
              </a:r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MCs 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om NEO patients were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nalyzed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or their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ytolytic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ctivity in an ADCC assay using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stuzumab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2 µg/ml) and MCF-7 cell line at different effector to target cell ratios (E:T = 2:1, 5:1, 10:1, 20:1). PBMCs were incubated with target cells in medium alone or in the presence of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stuzumab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+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st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. Results are expressed as % of </a:t>
              </a:r>
              <a:r>
                <a:rPr lang="en-GB" sz="10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1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r specific </a:t>
              </a:r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ease.</a:t>
              </a:r>
              <a:r>
                <a: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nels </a:t>
              </a:r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 and B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The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cγRIIIA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58V/V carriers (n=4) and F carriers (n=9) refer to PBMCs from patients carrying the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cγRIIIA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158V/V) wild type genotype (panel A) and the heterozygous (V/F) together with the mutated (F/F) genotype (panel B), </a:t>
              </a:r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pectively.</a:t>
              </a:r>
              <a:r>
                <a: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nels C and D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The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cγRIIIA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31H/H carriers (n=3) and R carriers (n=10) refer to PBMCs from patients carrying the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cγRIIA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131H/H) wild type genotype (panel C) and the heterozygous (H/R) together with the mutated (R/R) genotype (panel D), </a:t>
              </a:r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pectively.</a:t>
              </a:r>
              <a:r>
                <a: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0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breviations</a:t>
              </a:r>
              <a:r>
                <a:rPr lang="en-GB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EO,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eoadjuvant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st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stuzumab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just"/>
              <a:r>
                <a:rPr lang="it-IT" sz="1000" dirty="0"/>
                <a:t> </a:t>
              </a:r>
            </a:p>
          </p:txBody>
        </p:sp>
      </p:grpSp>
      <p:sp>
        <p:nvSpPr>
          <p:cNvPr id="6" name="CasellaDiTesto 5"/>
          <p:cNvSpPr txBox="1"/>
          <p:nvPr/>
        </p:nvSpPr>
        <p:spPr>
          <a:xfrm>
            <a:off x="251520" y="44624"/>
            <a:ext cx="25202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it-IT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le 2: Figure S1</a:t>
            </a:r>
            <a:endParaRPr lang="it-IT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64541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</TotalTime>
  <Words>267</Words>
  <Application>Microsoft Office PowerPoint</Application>
  <PresentationFormat>Presentazione su schermo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iaPia Pistillo</dc:creator>
  <cp:lastModifiedBy>MariaPia Pistillo</cp:lastModifiedBy>
  <cp:revision>29</cp:revision>
  <cp:lastPrinted>2015-10-05T06:48:35Z</cp:lastPrinted>
  <dcterms:created xsi:type="dcterms:W3CDTF">2015-04-24T14:06:52Z</dcterms:created>
  <dcterms:modified xsi:type="dcterms:W3CDTF">2015-10-07T16:50:25Z</dcterms:modified>
</cp:coreProperties>
</file>